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ADA269A-54C0-4333-8E17-880C084C9D0B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53F2AF-63BF-4364-B010-0781417B75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7922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4E56DF-63EA-B022-9E17-E3C9449674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9A379C8-55E3-2354-8DC1-2A73D5606D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BB606F-1D07-8802-508F-3BF67E2298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FCEF1-82EC-441B-B1DF-92608490E4EF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DC64E6-3AA7-F6D5-C074-53DE54989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B00BEF-32F5-1214-F9D2-281D3E8A0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B993D-A3BC-4224-9279-EC8BC4A4F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7779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1E96BF-0069-25D1-1767-BAE7F3BA1D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933F8B-957C-76AE-39B4-E6A6E3F62A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864868-3369-8594-F0BC-FE36CD1959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FCEF1-82EC-441B-B1DF-92608490E4EF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911E24-0BD5-3405-A95E-7E01EA5A35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B6AB04-1E94-88CC-A65E-53E2E4F57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B993D-A3BC-4224-9279-EC8BC4A4F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22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4DB3235-B262-6575-68F0-22071BF7F2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C05316-EBFB-4193-51A3-6018225BB4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2DE185-B648-1CFE-FFFF-2AA06C9D53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FCEF1-82EC-441B-B1DF-92608490E4EF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B411B0-231E-F1AB-F233-210E96C5F0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5BD48E-EAFF-7661-FEAB-0D20D945F8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B993D-A3BC-4224-9279-EC8BC4A4F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688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96702C-A38A-E870-F7E7-B13C402ABA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4B68EF-F839-0228-10FB-DB39611876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06AD10-3661-915F-2E3E-5698A78141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FCEF1-82EC-441B-B1DF-92608490E4EF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E68CAF-53F6-2692-5FAF-F7C243AD63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4650BA-6AA3-B420-871C-7203938B9E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B993D-A3BC-4224-9279-EC8BC4A4F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64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A7249F-7593-B3AA-4251-79F246A37B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7DD887-E823-1FA9-1754-2134500D37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2355B1-5963-3DDB-03FE-4216EE1199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FCEF1-82EC-441B-B1DF-92608490E4EF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B6D8E4-9858-8397-87C2-EE61D85F35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A2EDCB-AA6A-69B7-676E-950A65749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B993D-A3BC-4224-9279-EC8BC4A4F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954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B916A3-4A45-70E8-B449-1ECE11DF40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ACE989-2DE5-13A9-112A-43CC40AE74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99865F-1135-021F-706A-35DC5D1402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3FEA8D-E272-DCAE-1683-CFD5BFFD02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FCEF1-82EC-441B-B1DF-92608490E4EF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A859A2-47D1-7E95-5137-9F06CF67C8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D365BD-67DD-B66D-E8AD-BDE4599D3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B993D-A3BC-4224-9279-EC8BC4A4F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307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32FAB8-F75F-14C1-598A-0507369D48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C2B467-FF8B-D3A1-7CB0-404A220790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57029F-91F3-5BF8-1EDB-1DEA599103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D4922CC-6833-6920-A004-8A6456872A3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877F94C-A400-9D3C-2F5F-565B02AB83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5D50648-65C3-21F5-C2BD-226BA3649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FCEF1-82EC-441B-B1DF-92608490E4EF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EEA0FD2-1EFC-1245-F6EF-2BE06BE18B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E608DFF-6A7E-F542-6BBD-62822F675D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B993D-A3BC-4224-9279-EC8BC4A4F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434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37F084-7769-4C28-EB7C-E55A7BF6ED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18E138E-6B0A-F18E-3DFE-975EDE82F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FCEF1-82EC-441B-B1DF-92608490E4EF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E23119-66BB-5EC3-5712-BA8A1FC72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6F7F6F3-CE9D-3FF8-1C97-C8CCC14364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B993D-A3BC-4224-9279-EC8BC4A4F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691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F8D459-B38C-2AE7-B058-47061123BB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FCEF1-82EC-441B-B1DF-92608490E4EF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085A8FD-FED8-0DA7-4347-0BDE8056E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1E3C441-E31D-8134-D7F5-3D1CBE745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B993D-A3BC-4224-9279-EC8BC4A4F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975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071F43-4B26-0D00-2989-D1656DABEA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EE792B-5699-7332-DF19-70FD3179C6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43350B-7BF2-411C-3697-B081436D85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35BCC4-F7C2-1AD0-72D9-16152FCD0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FCEF1-82EC-441B-B1DF-92608490E4EF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480444-BE25-8A09-9567-B3B128A7C0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B0F736-C288-FD36-FC13-FAB36C67A1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B993D-A3BC-4224-9279-EC8BC4A4F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52482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B20D37-2BB7-F8A5-15A8-62701932E9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8C1EB2B-18A6-486D-7F6C-8CB228EBCD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2B0EE7-7835-AD97-C609-0CE4645120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938E26-B494-FBAF-9B8D-E7D9C1E90A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FCEF1-82EC-441B-B1DF-92608490E4EF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67C4C7-8BBB-0F74-A63C-6FC31F9DF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9E8CF6-2263-42FB-E045-0EF06E5B2F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B993D-A3BC-4224-9279-EC8BC4A4F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235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4F28CC-7973-7EBA-38C3-72C637FAE6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A1E11A-C2E1-5FCB-B7D5-6AC0500BBA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60E85E-04D9-8E37-DDDA-6983CB3B3C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2FCEF1-82EC-441B-B1DF-92608490E4EF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2140AB-035D-A4DF-6613-62D2DCE6DE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014E97-BA6D-1623-FE41-FBF7409B37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8B993D-A3BC-4224-9279-EC8BC4A4F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1223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79A406B8-5603-A71A-3A0A-0844BD6C86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5931" y="658665"/>
            <a:ext cx="4148328" cy="234696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A95DE7B-DD4E-41B0-C7D7-65DDD38A9730}"/>
              </a:ext>
            </a:extLst>
          </p:cNvPr>
          <p:cNvSpPr txBox="1"/>
          <p:nvPr/>
        </p:nvSpPr>
        <p:spPr>
          <a:xfrm>
            <a:off x="2860287" y="3081098"/>
            <a:ext cx="6095256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. Comparison of embryo head size and eye morphology after inhibitor SB431542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images of untreated and inhibitor-treated embryos. Brightfield images show no significant morphological changes in eyes on the 12XSBE:GFP background after inhibitor treatment (A = no treatment, C = inhibitor; scale = 100 um). Overall head and body size was slightly smaller after inhibitor, representative fluorescent images shown (B = no treatment, D = inhibitor; scale = 100 um). Brightfield images show no significant morphological changes in eyes on th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uf41:GFP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ackground after inhibitor treatment (E = no treatment, G = inhibitor; scale = 100 um). Overall head and body size was slightly smaller after inhibitor, representative fluorescent images shown (F = no treatment, H = inhibitor; scale = 400 um). Note: gain was increased to show body shape in the fluorescent images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936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</TotalTime>
  <Words>16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, Hang-Jing</dc:creator>
  <cp:lastModifiedBy>Wu, Hang-Jing</cp:lastModifiedBy>
  <cp:revision>25</cp:revision>
  <dcterms:created xsi:type="dcterms:W3CDTF">2022-07-20T20:38:46Z</dcterms:created>
  <dcterms:modified xsi:type="dcterms:W3CDTF">2022-08-04T20:57:29Z</dcterms:modified>
</cp:coreProperties>
</file>